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93" r:id="rId2"/>
    <p:sldId id="287" r:id="rId3"/>
    <p:sldId id="319" r:id="rId4"/>
    <p:sldId id="333" r:id="rId5"/>
    <p:sldId id="311" r:id="rId6"/>
    <p:sldId id="337" r:id="rId7"/>
    <p:sldId id="338" r:id="rId8"/>
    <p:sldId id="334" r:id="rId9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3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72" autoAdjust="0"/>
    <p:restoredTop sz="94660"/>
  </p:normalViewPr>
  <p:slideViewPr>
    <p:cSldViewPr snapToGrid="0">
      <p:cViewPr>
        <p:scale>
          <a:sx n="150" d="100"/>
          <a:sy n="150" d="100"/>
        </p:scale>
        <p:origin x="1824" y="-2118"/>
      </p:cViewPr>
      <p:guideLst>
        <p:guide orient="horz" pos="312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842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4493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1324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426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8358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138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451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480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878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5985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44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748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41133-169B-4DE5-9F5F-DC1A31790C32}" type="datetimeFigureOut">
              <a:rPr kumimoji="1" lang="ja-JP" altLang="en-US" smtClean="0"/>
              <a:t>2022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8DEFF9-E865-473A-AD45-64ACDBD980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849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84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  <p:sldLayoutId id="2147483683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8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8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package" Target="../embeddings/Microsoft_Excel_Worksheet1.xlsx"/><Relationship Id="rId1" Type="http://schemas.openxmlformats.org/officeDocument/2006/relationships/slideLayout" Target="../slideLayouts/slideLayout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package" Target="../embeddings/Microsoft_Excel_Worksheet2.xlsx"/><Relationship Id="rId1" Type="http://schemas.openxmlformats.org/officeDocument/2006/relationships/slideLayout" Target="../slideLayouts/slideLayout8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package" Target="../embeddings/Microsoft_Excel_Worksheet3.xlsx"/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2970CBB-7E88-46CE-8495-3BEA106AA5A4}"/>
              </a:ext>
            </a:extLst>
          </p:cNvPr>
          <p:cNvSpPr txBox="1"/>
          <p:nvPr/>
        </p:nvSpPr>
        <p:spPr>
          <a:xfrm>
            <a:off x="2928459" y="9321225"/>
            <a:ext cx="18962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Figure S1</a:t>
            </a:r>
            <a:endParaRPr kumimoji="1" lang="ja-JP" altLang="en-US" sz="3200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029A2410-1914-4EFF-AFB0-A28C468B396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25866" y="3182180"/>
            <a:ext cx="6084000" cy="231348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D4C8361-C86B-40D1-990D-390799F8B848}"/>
              </a:ext>
            </a:extLst>
          </p:cNvPr>
          <p:cNvSpPr txBox="1"/>
          <p:nvPr/>
        </p:nvSpPr>
        <p:spPr>
          <a:xfrm>
            <a:off x="447560" y="5577111"/>
            <a:ext cx="616230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12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Figure S1.</a:t>
            </a:r>
            <a:r>
              <a:rPr lang="en-GB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ypical examples of discrepancies between the number of opaque zones in an otolith (a) and translucent zones in a vertebra (b) from the same individual: a 433 mm total length cultured male </a:t>
            </a:r>
            <a:r>
              <a:rPr lang="en-GB" altLang="ja-JP" sz="1200" i="1" kern="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akifugu</a:t>
            </a:r>
            <a:r>
              <a:rPr lang="en-GB" altLang="ja-JP" sz="1200" i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GB" altLang="ja-JP" sz="1200" i="1" kern="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rubripes</a:t>
            </a:r>
            <a:r>
              <a:rPr lang="en-GB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, confirmed to be 2 years old. Arrowheads indicate the opaque and translucent zones in the otolith and vertebra, respectively. Scale bars: 1 mm.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13220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E76A311-D1D7-44B5-A804-934F291F0687}"/>
              </a:ext>
            </a:extLst>
          </p:cNvPr>
          <p:cNvSpPr txBox="1"/>
          <p:nvPr/>
        </p:nvSpPr>
        <p:spPr>
          <a:xfrm>
            <a:off x="2928459" y="9321225"/>
            <a:ext cx="17879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Figure S2</a:t>
            </a:r>
            <a:endParaRPr kumimoji="1" lang="ja-JP" altLang="en-US" sz="3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6859DC5-0946-4374-9C45-1BDA1A5DFB5A}"/>
              </a:ext>
            </a:extLst>
          </p:cNvPr>
          <p:cNvSpPr txBox="1"/>
          <p:nvPr/>
        </p:nvSpPr>
        <p:spPr>
          <a:xfrm>
            <a:off x="322430" y="6655882"/>
            <a:ext cx="621129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nthly changes of total length (a) and otolith radius (b)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juvenile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ifugu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ripes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96)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ught from nursery grounds: inner part of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iake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y (circle) and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tsushiro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y (triangle). The grey symbols indicate wild fish and th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 symbols indicate hatchery-origin fish.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ymbols of 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lith with one opaque zone were blackened and the dashed line indicate mean first opaque zone radius of otoliths from all age-estimated fish (b).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BEB2118-3676-43E9-BD88-C72842CE218B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27806" y="2608491"/>
            <a:ext cx="3000538" cy="37986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75015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E76A311-D1D7-44B5-A804-934F291F0687}"/>
              </a:ext>
            </a:extLst>
          </p:cNvPr>
          <p:cNvSpPr txBox="1"/>
          <p:nvPr/>
        </p:nvSpPr>
        <p:spPr>
          <a:xfrm>
            <a:off x="2928460" y="9321225"/>
            <a:ext cx="22210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Figure S3</a:t>
            </a:r>
            <a:endParaRPr kumimoji="1" lang="ja-JP" altLang="en-US" sz="3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368817B-DD62-48CB-B7BF-F1B8E27F2778}"/>
              </a:ext>
            </a:extLst>
          </p:cNvPr>
          <p:cNvSpPr txBox="1"/>
          <p:nvPr/>
        </p:nvSpPr>
        <p:spPr>
          <a:xfrm>
            <a:off x="574469" y="6347323"/>
            <a:ext cx="5709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nthly changes of marginal increment on otoliths of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ifugu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ripes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E8AC0765-36F6-4D48-B830-EA2822E6AEB7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91430" y="3246120"/>
            <a:ext cx="2875135" cy="3017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95546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E76A311-D1D7-44B5-A804-934F291F0687}"/>
              </a:ext>
            </a:extLst>
          </p:cNvPr>
          <p:cNvSpPr txBox="1"/>
          <p:nvPr/>
        </p:nvSpPr>
        <p:spPr>
          <a:xfrm>
            <a:off x="2928460" y="9321225"/>
            <a:ext cx="22210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Figure S4</a:t>
            </a:r>
            <a:endParaRPr kumimoji="1" lang="ja-JP" altLang="en-US" sz="3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368817B-DD62-48CB-B7BF-F1B8E27F2778}"/>
              </a:ext>
            </a:extLst>
          </p:cNvPr>
          <p:cNvSpPr txBox="1"/>
          <p:nvPr/>
        </p:nvSpPr>
        <p:spPr>
          <a:xfrm>
            <a:off x="574469" y="6347323"/>
            <a:ext cx="59025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von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rtalanffy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th model for wild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ifugu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ripes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ong this and previous studies. This study used otoliths and the other studies used vertebrae for age estimation.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11CA83D6-FE32-43A3-AD9A-3068AC8A51BA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417" y="3617186"/>
            <a:ext cx="6497465" cy="2730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28328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03586E7-17EC-4894-A464-7F1BFF18F7C0}"/>
              </a:ext>
            </a:extLst>
          </p:cNvPr>
          <p:cNvSpPr txBox="1"/>
          <p:nvPr/>
        </p:nvSpPr>
        <p:spPr>
          <a:xfrm>
            <a:off x="2742636" y="9321225"/>
            <a:ext cx="18895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Table S1</a:t>
            </a:r>
            <a:endParaRPr kumimoji="1" lang="ja-JP" altLang="en-US" sz="32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103647A-D444-45D8-8019-F0D380792C2C}"/>
              </a:ext>
            </a:extLst>
          </p:cNvPr>
          <p:cNvSpPr txBox="1"/>
          <p:nvPr/>
        </p:nvSpPr>
        <p:spPr>
          <a:xfrm>
            <a:off x="1719263" y="4129153"/>
            <a:ext cx="34194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valence of aberrant otolith in wild, hatchery-origin, and cultured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ifugu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ripes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0FFF0586-FF25-406E-BC4E-56E1D60176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8586344"/>
              </p:ext>
            </p:extLst>
          </p:nvPr>
        </p:nvGraphicFramePr>
        <p:xfrm>
          <a:off x="1719263" y="4646613"/>
          <a:ext cx="3419475" cy="1771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3419615" imgH="1771497" progId="Excel.Sheet.12">
                  <p:embed/>
                </p:oleObj>
              </mc:Choice>
              <mc:Fallback>
                <p:oleObj name="Worksheet" r:id="rId2" imgW="3419615" imgH="1771497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19263" y="4646613"/>
                        <a:ext cx="3419475" cy="1771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434922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94DA6BF-DD69-482E-8DE7-488283190132}"/>
              </a:ext>
            </a:extLst>
          </p:cNvPr>
          <p:cNvSpPr txBox="1"/>
          <p:nvPr/>
        </p:nvSpPr>
        <p:spPr>
          <a:xfrm>
            <a:off x="2928459" y="9321225"/>
            <a:ext cx="168164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Table </a:t>
            </a:r>
            <a:r>
              <a:rPr lang="en-US" altLang="ja-JP" sz="3200" dirty="0"/>
              <a:t>S2</a:t>
            </a:r>
            <a:endParaRPr kumimoji="1" lang="ja-JP" altLang="en-US" sz="3200" dirty="0"/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4EE88897-A2FA-4283-9C04-AE38D9D33A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1563910"/>
              </p:ext>
            </p:extLst>
          </p:nvPr>
        </p:nvGraphicFramePr>
        <p:xfrm>
          <a:off x="346075" y="2622550"/>
          <a:ext cx="6165850" cy="337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6400800" imgH="3495516" progId="Excel.Sheet.12">
                  <p:embed/>
                </p:oleObj>
              </mc:Choice>
              <mc:Fallback>
                <p:oleObj name="Worksheet" r:id="rId2" imgW="6400800" imgH="3495516" progId="Excel.Sheet.12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4EE88897-A2FA-4283-9C04-AE38D9D33A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6075" y="2622550"/>
                        <a:ext cx="6165850" cy="3371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42D86DE-AACB-4657-AC3D-1EE76BECF855}"/>
              </a:ext>
            </a:extLst>
          </p:cNvPr>
          <p:cNvSpPr txBox="1"/>
          <p:nvPr/>
        </p:nvSpPr>
        <p:spPr>
          <a:xfrm>
            <a:off x="346076" y="1773019"/>
            <a:ext cx="61658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kaike’s information criterion corrected for small-sample bias (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Cc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each candidate models fitted for relationships between total length (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otolith radius (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between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vertebral radius (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Lowest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Cc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ach dataset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denoted in bold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1" lang="el-GR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200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kaike difference;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kumimoji="1" lang="en-US" altLang="ja-JP" sz="1200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kaike weight.</a:t>
            </a:r>
          </a:p>
        </p:txBody>
      </p:sp>
    </p:spTree>
    <p:extLst>
      <p:ext uri="{BB962C8B-B14F-4D97-AF65-F5344CB8AC3E}">
        <p14:creationId xmlns:p14="http://schemas.microsoft.com/office/powerpoint/2010/main" val="3333882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94DA6BF-DD69-482E-8DE7-488283190132}"/>
              </a:ext>
            </a:extLst>
          </p:cNvPr>
          <p:cNvSpPr txBox="1"/>
          <p:nvPr/>
        </p:nvSpPr>
        <p:spPr>
          <a:xfrm>
            <a:off x="2928459" y="9321225"/>
            <a:ext cx="168164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Table </a:t>
            </a:r>
            <a:r>
              <a:rPr lang="en-US" altLang="ja-JP" sz="3200" dirty="0"/>
              <a:t>S3</a:t>
            </a:r>
            <a:endParaRPr kumimoji="1" lang="ja-JP" altLang="en-US" sz="3200" dirty="0"/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4EE88897-A2FA-4283-9C04-AE38D9D33A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7439899"/>
              </p:ext>
            </p:extLst>
          </p:nvPr>
        </p:nvGraphicFramePr>
        <p:xfrm>
          <a:off x="-26988" y="2432050"/>
          <a:ext cx="6819901" cy="5041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7077215" imgH="5229168" progId="Excel.Sheet.12">
                  <p:embed/>
                </p:oleObj>
              </mc:Choice>
              <mc:Fallback>
                <p:oleObj name="Worksheet" r:id="rId2" imgW="7077215" imgH="5229168" progId="Excel.Sheet.12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4EE88897-A2FA-4283-9C04-AE38D9D33A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26988" y="2432050"/>
                        <a:ext cx="6819901" cy="5041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42D86DE-AACB-4657-AC3D-1EE76BECF855}"/>
              </a:ext>
            </a:extLst>
          </p:cNvPr>
          <p:cNvSpPr txBox="1"/>
          <p:nvPr/>
        </p:nvSpPr>
        <p:spPr>
          <a:xfrm>
            <a:off x="-1" y="1601053"/>
            <a:ext cx="67929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.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th models fitted to length-at-age and mass-at-age data, separately by sex and origin, for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ifugu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ripe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ach best models selected by Akaike’s information criterion corrected for small-sample bias (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Cc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re denoted in bold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12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sz="12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total length (mm) and total mass (g) at age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</a:t>
            </a:r>
            <a:r>
              <a:rPr kumimoji="1" lang="el-GR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200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kaike difference;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kumimoji="1" lang="en-US" altLang="ja-JP" sz="1200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kaike weight; VBGM, von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rtalanffy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th model.</a:t>
            </a:r>
          </a:p>
        </p:txBody>
      </p:sp>
    </p:spTree>
    <p:extLst>
      <p:ext uri="{BB962C8B-B14F-4D97-AF65-F5344CB8AC3E}">
        <p14:creationId xmlns:p14="http://schemas.microsoft.com/office/powerpoint/2010/main" val="41681648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03586E7-17EC-4894-A464-7F1BFF18F7C0}"/>
              </a:ext>
            </a:extLst>
          </p:cNvPr>
          <p:cNvSpPr txBox="1"/>
          <p:nvPr/>
        </p:nvSpPr>
        <p:spPr>
          <a:xfrm>
            <a:off x="2742636" y="9321225"/>
            <a:ext cx="18895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Table S4</a:t>
            </a:r>
            <a:endParaRPr kumimoji="1" lang="ja-JP" altLang="en-US" sz="32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103647A-D444-45D8-8019-F0D380792C2C}"/>
              </a:ext>
            </a:extLst>
          </p:cNvPr>
          <p:cNvSpPr txBox="1"/>
          <p:nvPr/>
        </p:nvSpPr>
        <p:spPr>
          <a:xfrm>
            <a:off x="1304925" y="3589437"/>
            <a:ext cx="424815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4.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von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rtalanffy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th model parameters for wild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ifugu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ripes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ong this and previous studies.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altLang="ja-JP" sz="12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∞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theoretical asymptotic total length (mm)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growth rate coefficient;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sz="12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theoretical age (years) at zero total length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0FFF0586-FF25-406E-BC4E-56E1D60176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2081945"/>
              </p:ext>
            </p:extLst>
          </p:nvPr>
        </p:nvGraphicFramePr>
        <p:xfrm>
          <a:off x="1355725" y="4681538"/>
          <a:ext cx="4248150" cy="1438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248258" imgH="1438116" progId="Excel.Sheet.12">
                  <p:embed/>
                </p:oleObj>
              </mc:Choice>
              <mc:Fallback>
                <p:oleObj name="Worksheet" r:id="rId2" imgW="4248258" imgH="1438116" progId="Excel.Sheet.12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0FFF0586-FF25-406E-BC4E-56E1D60176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55725" y="4681538"/>
                        <a:ext cx="4248150" cy="1438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70179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2" id="{37B33189-E936-47C1-9120-21A4D9BAB2EE}" vid="{D63C94CC-5A48-45FF-9FFE-3E8B5AF0F06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A4用</Template>
  <TotalTime>143313</TotalTime>
  <Words>436</Words>
  <Application>Microsoft Office PowerPoint</Application>
  <PresentationFormat>A4 210 x 297 mm</PresentationFormat>
  <Paragraphs>16</Paragraphs>
  <Slides>8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テーマ</vt:lpstr>
      <vt:lpstr>Worksheet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mi Ogino</dc:creator>
  <cp:lastModifiedBy>Yoshimi Ogino</cp:lastModifiedBy>
  <cp:revision>749</cp:revision>
  <cp:lastPrinted>2022-07-07T11:41:01Z</cp:lastPrinted>
  <dcterms:created xsi:type="dcterms:W3CDTF">2020-05-22T11:44:53Z</dcterms:created>
  <dcterms:modified xsi:type="dcterms:W3CDTF">2022-07-19T04:52:41Z</dcterms:modified>
</cp:coreProperties>
</file>